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6A51D8-221C-476F-9284-FE016816727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51D157-26D1-4818-B327-8354A35EB3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397A05-9E23-4A07-B4D3-8C8D7656C5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EBF0A-2224-4389-BA59-1FD589B867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D32ABB-7213-4B0A-99A8-B6B86F1E21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1EB7E-89CC-440C-A00E-9B057D432C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7765D-95F0-4B6F-9EAF-D8856770BC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E7067-4966-470E-84C0-69E84618DE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810363-3604-480E-B653-4D4E508679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F0BAC-7D4C-4694-9B3C-FB29C6372E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0593F7-B64A-49C7-A0DD-0E0E264B68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0112A-016E-4886-82D0-5A4A6DDF93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rmAutofit/>
          </a:bodyPr>
          <a:p>
            <a:pPr marL="298440" indent="-2984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47640" indent="-24912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995400" indent="-19836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393920" indent="-19836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792440" indent="-19872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792440" indent="-19872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792440" indent="-19872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64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79560" rIns="79560" tIns="39960" bIns="39960" anchor="t">
            <a:noAutofit/>
          </a:bodyPr>
          <a:lstStyle>
            <a:lvl1pPr indent="0" algn="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fld id="{1E1C9777-57DF-4688-9C7E-1EBB6097505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7"/>
          <p:cNvSpPr/>
          <p:nvPr/>
        </p:nvSpPr>
        <p:spPr>
          <a:xfrm>
            <a:off x="676440" y="1187280"/>
            <a:ext cx="5360760" cy="29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 marL="237960" indent="-237960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141560" y="1952640"/>
            <a:ext cx="1920600" cy="233352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3238560" y="1952640"/>
            <a:ext cx="1979640" cy="18781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1557360" y="1568520"/>
            <a:ext cx="1871640" cy="627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ecursor DC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Lin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DR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CD11c/CD123 analys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789360" y="1568520"/>
            <a:ext cx="1511280" cy="627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erminal DC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DCA-1, -2, -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nalys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27"/>
          <p:cNvSpPr/>
          <p:nvPr/>
        </p:nvSpPr>
        <p:spPr>
          <a:xfrm>
            <a:off x="736560" y="4286160"/>
            <a:ext cx="5572080" cy="29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V="1">
            <a:off x="1719360" y="5581800"/>
            <a:ext cx="4178160" cy="1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719360" y="5494320"/>
            <a:ext cx="0" cy="17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573280" y="5494320"/>
            <a:ext cx="0" cy="17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338640" y="5494320"/>
            <a:ext cx="0" cy="17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140360" y="5494320"/>
            <a:ext cx="0" cy="17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743360" y="5494320"/>
            <a:ext cx="0" cy="17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069920" y="4859280"/>
            <a:ext cx="919080" cy="537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rst Diagnostic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FD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429920" y="4500720"/>
            <a:ext cx="1647360" cy="38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nduction/ Consolid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735280" y="4908600"/>
            <a:ext cx="1353960" cy="38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ematopoietic recover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201560" y="4932360"/>
            <a:ext cx="799920" cy="68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omple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emi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CR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985640" y="5003640"/>
            <a:ext cx="722160" cy="3848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elapse?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RE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320120" y="5670720"/>
            <a:ext cx="560520" cy="23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ime 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488320" y="5670720"/>
            <a:ext cx="230040" cy="23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250440" y="5680080"/>
            <a:ext cx="230040" cy="23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039920" y="5680080"/>
            <a:ext cx="965880" cy="23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9       12      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440240" y="5494320"/>
            <a:ext cx="0" cy="17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949280" y="5680080"/>
            <a:ext cx="299880" cy="23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094360" y="5494320"/>
            <a:ext cx="0" cy="17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16200000">
            <a:off x="2058840" y="4328640"/>
            <a:ext cx="88920" cy="863640"/>
          </a:xfrm>
          <a:custGeom>
            <a:avLst/>
            <a:gdLst>
              <a:gd name="textAreaLeft" fmla="*/ 0 w 88920"/>
              <a:gd name="textAreaRight" fmla="*/ 62280 w 88920"/>
              <a:gd name="textAreaTop" fmla="*/ 36000 h 863640"/>
              <a:gd name="textAreaBottom" fmla="*/ 828000 h 863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635440" y="5668920"/>
            <a:ext cx="618480" cy="23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onth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720800" y="5894280"/>
            <a:ext cx="854280" cy="616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o respon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24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NR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720800" y="6580080"/>
            <a:ext cx="3875040" cy="464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omplete Remission and Relapse after &gt; 15 month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24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CR/RE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731960" y="6934320"/>
            <a:ext cx="4316400" cy="806400"/>
          </a:xfrm>
          <a:prstGeom prst="rightArrow">
            <a:avLst>
              <a:gd name="adj1" fmla="val 49509"/>
              <a:gd name="adj2" fmla="val 51891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425680" y="7110360"/>
            <a:ext cx="2332080" cy="46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isease Free Survival for &gt;2 yea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24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(CR/DF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522440" y="6580080"/>
            <a:ext cx="149040" cy="930240"/>
          </a:xfrm>
          <a:custGeom>
            <a:avLst/>
            <a:gdLst>
              <a:gd name="textAreaLeft" fmla="*/ 43920 w 149040"/>
              <a:gd name="textAreaRight" fmla="*/ 149400 w 149040"/>
              <a:gd name="textAreaTop" fmla="*/ 38520 h 930240"/>
              <a:gd name="textAreaBottom" fmla="*/ 891720 h 9302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900"/>
                  <a:pt x="0" y="1800"/>
                </a:cubicBezTo>
                <a:lnTo>
                  <a:pt x="0" y="19800"/>
                </a:lnTo>
                <a:cubicBezTo>
                  <a:pt x="0" y="207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rot="16200000">
            <a:off x="677160" y="6696000"/>
            <a:ext cx="987480" cy="627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9560" rIns="79560" tIns="39960" bIns="3996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mplete Remission (C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3315240" y="4540680"/>
            <a:ext cx="42840" cy="1504800"/>
          </a:xfrm>
          <a:custGeom>
            <a:avLst/>
            <a:gdLst>
              <a:gd name="textAreaLeft" fmla="*/ 0 w 42840"/>
              <a:gd name="textAreaRight" fmla="*/ 30240 w 42840"/>
              <a:gd name="textAreaTop" fmla="*/ 62640 h 1504800"/>
              <a:gd name="textAreaBottom" fmla="*/ 1442160 h 15048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595840" y="5494320"/>
            <a:ext cx="0" cy="176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450760" y="5678640"/>
            <a:ext cx="299880" cy="23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9560" rIns="79560" tIns="39960" bIns="39960" anchor="t">
            <a:spAutoFit/>
          </a:bodyPr>
          <a:p>
            <a:pPr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836640" y="179280"/>
            <a:ext cx="518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797040"/>
                <a:tab algn="l" pos="1593720"/>
                <a:tab algn="l" pos="2390760"/>
                <a:tab algn="l" pos="3187800"/>
                <a:tab algn="l" pos="3984480"/>
                <a:tab algn="l" pos="4781520"/>
                <a:tab algn="l" pos="5578560"/>
                <a:tab algn="l" pos="6375240"/>
                <a:tab algn="l" pos="7172280"/>
                <a:tab algn="l" pos="7969320"/>
                <a:tab algn="l" pos="8766000"/>
                <a:tab algn="l" pos="9563040"/>
                <a:tab algn="l" pos="1036008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ppl. Fig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1T11:41:00Z</dcterms:created>
  <dc:creator>rickmann</dc:creator>
  <dc:description/>
  <dc:language>en-US</dc:language>
  <cp:lastModifiedBy>rickmann</cp:lastModifiedBy>
  <dcterms:modified xsi:type="dcterms:W3CDTF">2013-02-15T11:21:04Z</dcterms:modified>
  <cp:revision>460</cp:revision>
  <dc:subject/>
  <dc:title>Slide 1</dc:title>
</cp:coreProperties>
</file>